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 lvl="0">
      <a:defRPr lang="ko-KR"/>
    </a:defPPr>
    <a:lvl1pPr marL="0" lv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lvl="1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lvl="2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lvl="3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lvl="4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lvl="5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lvl="6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lvl="7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lvl="8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76420A-BDBA-6761-5BA5-6EF6DD43BA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F186763-2724-0F41-DE33-3FAA6501BE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973B3B9-C23E-E19B-5639-83BE7B6B8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BDEDA27-BEB7-9019-5FCE-0AA1B6E50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85AEC8D-65D3-7497-AD6E-7054DE210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3534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AAF09DF-27BA-84B3-CD7D-4B9F06610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477437D-E253-F153-1119-6072523452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61B9F9E-74F5-011A-F1DE-F2D8EF1D8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E976C58-3B45-AD2F-CCD5-10B56A3F2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AF6CB70-B6FA-073F-AB48-B3CA618F2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9354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6FDB46B-C778-8122-3725-EE13CF4705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B3B47AA-1587-6196-FBC8-395677A456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00D34-5514-797A-3907-A34D9C768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B62F2A9-F33B-C0DC-6E5E-A31B01BB8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F1F9628-10DD-36B7-2BD9-014D42728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840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E65FB1-C4AE-3999-C0DE-97D2D0CC9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ADEC919-82DE-BA52-FF7A-D58F80485E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3A2B79B-6498-B656-B25C-B7B0AB268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C458FAE-036D-5328-7636-D51F0CF70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97EDD6-3618-C818-B6E1-FA2145E02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236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8A3A36-27F7-E20D-3DAF-6CD83C545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324FBB-48E9-9BA1-B208-4900ADA6BF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D4645B0-A188-E130-E69E-2F3B2C969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77263EC-0F2B-4369-E31C-872921085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A47C8A0-ECCD-5A6B-AE47-D3C08400D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8910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5448C5E-C674-1C9C-8A1B-6407E2D674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0159A0D-0836-C0CF-D01F-8CD39141F6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51568D5-2657-1399-FD71-E3EB74258B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D81D00D-AB8F-543F-BF7C-4C03ECED6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13D5F44-9D9E-35C1-76AF-33B1CDCBD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B39B2CB-E9F7-B5E6-C6B8-EB3BE8C0A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595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60F950B-B621-19DF-4564-5E3ED83FC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614A98C-89CC-9309-8439-1108A424AF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3CBFE07-9546-3F3C-6349-D76212C37E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E76A5F5-E724-2A42-08B6-A354FA6BA6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CD25B8A-55A2-8306-AE9C-BF345C4C83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2725637-AF48-B36F-737E-9D8BF0489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3A3F310-F025-3950-603B-71A530872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67FBDBB-4D26-0D68-05E4-1AA28C43C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6857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B5C2DF-B475-4EA0-0527-F81F1E7DB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838C311-6555-6689-BEB2-43AB0D62C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73B9FEC-80F3-EBC2-4310-D90238E1C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F85152F-FCB1-4E5B-546A-CAE35CDFA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9868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11DEB2A-4DDC-AE3C-75BC-9522186B1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CE6CC8D-A541-773C-D2BA-8A1C46C51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8189C89-2BC7-B40F-C3CB-0462BFF21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4040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AE0822-3A31-A087-ED6B-4DFC41B18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9819252-813F-8542-551F-7F6A5A5171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58A41D4-12AD-F4B7-C801-D7FCD6E6FA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764363-A10C-A69F-7745-1C0EBFF2E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89172E0-0FCC-0906-CB0A-A01E91D20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722F41-F9A6-A108-5B4D-94FEA0BF9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522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9763D7-D2EF-6821-065E-A22452284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2D8437D5-43CD-896C-83D2-DB31F36DB6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0B6150-1F90-DE92-8E1A-A321FEB043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8385BA4-A4D0-AF99-C7CA-2344BDE70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1B65A6D-041B-1F4B-2370-D3BD2EB18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3B4FA31-0D24-88CE-637C-2CB23CD40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7953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FE660CB-D5C5-CFEA-B0AD-0921303E9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3D2ADEB-1817-8A92-9A8B-0EE6BAB07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FC5C639-E0B0-B29A-85B5-857C353AF5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79A8E-5FBA-4252-8EFF-35A20A514A7F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BE08DD-5C35-7F31-2475-5F3FD123AA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237E1F-CEE6-556F-05B0-070191599E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6DD8D-2404-4C77-89AC-CE0F2BE410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438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819A36-F460-BA5F-BD3B-FB4988D8E9E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/>
              <a:t>Table S1 Analysis Results</a:t>
            </a:r>
            <a:endParaRPr lang="ko-KR" altLang="en-US" dirty="0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3444212-B97E-7A20-0F34-C633BA20ECB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9743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BB092C-A0C3-0158-3826-2E51FE2CE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b="1" dirty="0"/>
              <a:t>Vehicle(n=19)</a:t>
            </a:r>
            <a:endParaRPr lang="ko-KR" altLang="en-US" b="1" dirty="0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1BD6DF0-AB86-0F5D-7E7D-13EBEE3B3F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 dirty="0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31773584-797B-E699-A09B-280558B21F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12720" t="15425" r="39412" b="5324"/>
          <a:stretch/>
        </p:blipFill>
        <p:spPr>
          <a:xfrm>
            <a:off x="5723964" y="896469"/>
            <a:ext cx="6163235" cy="573977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5E8ED202-00D0-9A7B-753F-FBC9375F45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12427" t="14902" r="52353" b="44706"/>
          <a:stretch/>
        </p:blipFill>
        <p:spPr>
          <a:xfrm>
            <a:off x="448237" y="1825625"/>
            <a:ext cx="5058415" cy="3263153"/>
          </a:xfrm>
          <a:prstGeom prst="rect">
            <a:avLst/>
          </a:prstGeom>
        </p:spPr>
      </p:pic>
      <p:sp>
        <p:nvSpPr>
          <p:cNvPr id="10" name="직사각형 9">
            <a:extLst>
              <a:ext uri="{FF2B5EF4-FFF2-40B4-BE49-F238E27FC236}">
                <a16:creationId xmlns:a16="http://schemas.microsoft.com/office/drawing/2014/main" id="{03DD61A3-1486-2CA3-3B34-DBD7E49B76EE}"/>
              </a:ext>
            </a:extLst>
          </p:cNvPr>
          <p:cNvSpPr/>
          <p:nvPr/>
        </p:nvSpPr>
        <p:spPr>
          <a:xfrm>
            <a:off x="1918447" y="3766354"/>
            <a:ext cx="744072" cy="464987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5AAB09DB-1CB3-2BED-E773-68B9ED366558}"/>
              </a:ext>
            </a:extLst>
          </p:cNvPr>
          <p:cNvCxnSpPr/>
          <p:nvPr/>
        </p:nvCxnSpPr>
        <p:spPr>
          <a:xfrm>
            <a:off x="6096000" y="2106706"/>
            <a:ext cx="2590800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21C2F689-CA0E-3772-F173-20A9C6121AB4}"/>
              </a:ext>
            </a:extLst>
          </p:cNvPr>
          <p:cNvCxnSpPr>
            <a:cxnSpLocks/>
          </p:cNvCxnSpPr>
          <p:nvPr/>
        </p:nvCxnSpPr>
        <p:spPr>
          <a:xfrm>
            <a:off x="6096000" y="5988424"/>
            <a:ext cx="4670611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C868C983-E6BD-9AF1-8CEB-E66DBCA0263D}"/>
              </a:ext>
            </a:extLst>
          </p:cNvPr>
          <p:cNvCxnSpPr>
            <a:cxnSpLocks/>
          </p:cNvCxnSpPr>
          <p:nvPr/>
        </p:nvCxnSpPr>
        <p:spPr>
          <a:xfrm>
            <a:off x="1918447" y="2626657"/>
            <a:ext cx="744072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1214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B276206-0DBE-B27C-3A53-47CAB22CA1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0360"/>
            <a:ext cx="10887636" cy="1325563"/>
          </a:xfrm>
        </p:spPr>
        <p:txBody>
          <a:bodyPr/>
          <a:lstStyle/>
          <a:p>
            <a:r>
              <a:rPr lang="en-US" altLang="ko-KR" b="1" dirty="0"/>
              <a:t>Vehicle(n=</a:t>
            </a:r>
            <a:r>
              <a:rPr lang="en-US" altLang="ko-KR" b="1"/>
              <a:t>10)_</a:t>
            </a:r>
            <a:r>
              <a:rPr lang="en-US" altLang="ko-KR" sz="3200"/>
              <a:t>First 10 mice in order of experiment</a:t>
            </a:r>
            <a:endParaRPr lang="ko-KR" altLang="en-US" dirty="0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9F18306-B33F-8E43-634A-DA6F8B7096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756E9553-8832-9F17-5BFE-FE2A315292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12794" t="14771" r="52867" b="45098"/>
          <a:stretch/>
        </p:blipFill>
        <p:spPr>
          <a:xfrm>
            <a:off x="280731" y="1825625"/>
            <a:ext cx="5201186" cy="3419194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E20CC6E9-3C6F-38BD-4889-D0C2FEF895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12720" t="14771" r="39118" b="5324"/>
          <a:stretch/>
        </p:blipFill>
        <p:spPr>
          <a:xfrm>
            <a:off x="5853953" y="1261362"/>
            <a:ext cx="5871883" cy="5479863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1677D972-9B5A-59A6-969B-D3F0B06A0904}"/>
              </a:ext>
            </a:extLst>
          </p:cNvPr>
          <p:cNvSpPr/>
          <p:nvPr/>
        </p:nvSpPr>
        <p:spPr>
          <a:xfrm>
            <a:off x="1775007" y="3900826"/>
            <a:ext cx="744072" cy="464987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06C827ED-9BA3-3FB2-36DA-69C74012210A}"/>
              </a:ext>
            </a:extLst>
          </p:cNvPr>
          <p:cNvCxnSpPr>
            <a:cxnSpLocks/>
          </p:cNvCxnSpPr>
          <p:nvPr/>
        </p:nvCxnSpPr>
        <p:spPr>
          <a:xfrm>
            <a:off x="1792937" y="2698374"/>
            <a:ext cx="744072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9550D668-5A49-E5B2-1830-EC92E1D88803}"/>
              </a:ext>
            </a:extLst>
          </p:cNvPr>
          <p:cNvCxnSpPr/>
          <p:nvPr/>
        </p:nvCxnSpPr>
        <p:spPr>
          <a:xfrm>
            <a:off x="6149790" y="2465294"/>
            <a:ext cx="2590800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D44D8B9C-7CEF-CC8A-718B-5EF36D788055}"/>
              </a:ext>
            </a:extLst>
          </p:cNvPr>
          <p:cNvCxnSpPr>
            <a:cxnSpLocks/>
          </p:cNvCxnSpPr>
          <p:nvPr/>
        </p:nvCxnSpPr>
        <p:spPr>
          <a:xfrm>
            <a:off x="6087035" y="6131861"/>
            <a:ext cx="4670611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10430CE4-23B5-DD1A-F783-6838C6746C20}"/>
              </a:ext>
            </a:extLst>
          </p:cNvPr>
          <p:cNvSpPr/>
          <p:nvPr/>
        </p:nvSpPr>
        <p:spPr>
          <a:xfrm>
            <a:off x="9305365" y="1990165"/>
            <a:ext cx="2590800" cy="211567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600">
                <a:solidFill>
                  <a:srgbClr val="0070C0"/>
                </a:solidFill>
              </a:rPr>
              <a:t>The mean and standard deviation change slightly, but statistically, at P&lt;0.05 in both cases, there is no difference in the interpretation of the results</a:t>
            </a:r>
            <a:endParaRPr lang="ko-KR" altLang="en-US" sz="1600" dirty="0">
              <a:solidFill>
                <a:srgbClr val="0070C0"/>
              </a:solidFill>
            </a:endParaRPr>
          </a:p>
        </p:txBody>
      </p: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A93B6F36-DD58-7A81-F358-B6395AF5DD33}"/>
              </a:ext>
            </a:extLst>
          </p:cNvPr>
          <p:cNvCxnSpPr>
            <a:cxnSpLocks/>
          </p:cNvCxnSpPr>
          <p:nvPr/>
        </p:nvCxnSpPr>
        <p:spPr>
          <a:xfrm flipH="1" flipV="1">
            <a:off x="8601635" y="2491932"/>
            <a:ext cx="663388" cy="51098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>
            <a:extLst>
              <a:ext uri="{FF2B5EF4-FFF2-40B4-BE49-F238E27FC236}">
                <a16:creationId xmlns:a16="http://schemas.microsoft.com/office/drawing/2014/main" id="{C0528E75-11DA-96B3-7D29-03C2F8B244D1}"/>
              </a:ext>
            </a:extLst>
          </p:cNvPr>
          <p:cNvCxnSpPr/>
          <p:nvPr/>
        </p:nvCxnSpPr>
        <p:spPr>
          <a:xfrm>
            <a:off x="10399063" y="4105835"/>
            <a:ext cx="0" cy="1846730"/>
          </a:xfrm>
          <a:prstGeom prst="straightConnector1">
            <a:avLst/>
          </a:prstGeom>
          <a:ln w="2857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id="{6895A2A1-B4B5-5AEE-1FC1-0C66E96121F0}"/>
              </a:ext>
            </a:extLst>
          </p:cNvPr>
          <p:cNvCxnSpPr>
            <a:cxnSpLocks/>
          </p:cNvCxnSpPr>
          <p:nvPr/>
        </p:nvCxnSpPr>
        <p:spPr>
          <a:xfrm flipH="1">
            <a:off x="2621902" y="3237722"/>
            <a:ext cx="6643121" cy="66310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48906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5C168D-09D3-8F80-074A-B3C380C16C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5E907D-1774-3312-86A6-243CED1E18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</p:spPr>
        <p:txBody>
          <a:bodyPr/>
          <a:lstStyle/>
          <a:p>
            <a:r>
              <a:rPr lang="en-US" altLang="ko-KR" dirty="0"/>
              <a:t>N=</a:t>
            </a:r>
            <a:r>
              <a:rPr lang="en-US" altLang="ko-KR"/>
              <a:t>10(Initial 10): </a:t>
            </a:r>
            <a:r>
              <a:rPr lang="en-US" altLang="ko-KR" dirty="0"/>
              <a:t>ANOVA </a:t>
            </a:r>
            <a:r>
              <a:rPr lang="en-US" altLang="ko-KR" dirty="0">
                <a:solidFill>
                  <a:srgbClr val="FF0000"/>
                </a:solidFill>
              </a:rPr>
              <a:t>p=</a:t>
            </a:r>
            <a:r>
              <a:rPr lang="en-US" altLang="ko-KR">
                <a:solidFill>
                  <a:srgbClr val="FF0000"/>
                </a:solidFill>
              </a:rPr>
              <a:t>0.0455 </a:t>
            </a:r>
            <a:r>
              <a:rPr lang="en-US" altLang="ko-KR"/>
              <a:t>(Same post hoc analysis)</a:t>
            </a:r>
            <a:endParaRPr lang="en-US" altLang="ko-KR" dirty="0"/>
          </a:p>
          <a:p>
            <a:r>
              <a:rPr lang="en-US" altLang="ko-KR" dirty="0"/>
              <a:t>N=</a:t>
            </a:r>
            <a:r>
              <a:rPr lang="en-US" altLang="ko-KR"/>
              <a:t>19(Initial 10+9 additional mice): </a:t>
            </a:r>
            <a:r>
              <a:rPr lang="en-US" altLang="ko-KR" dirty="0"/>
              <a:t>ANOVA </a:t>
            </a:r>
            <a:r>
              <a:rPr lang="en-US" altLang="ko-KR" dirty="0">
                <a:solidFill>
                  <a:srgbClr val="FF0000"/>
                </a:solidFill>
              </a:rPr>
              <a:t>p=</a:t>
            </a:r>
            <a:r>
              <a:rPr lang="en-US" altLang="ko-KR">
                <a:solidFill>
                  <a:srgbClr val="FF0000"/>
                </a:solidFill>
              </a:rPr>
              <a:t>0.0302 </a:t>
            </a:r>
            <a:r>
              <a:rPr lang="en-US" altLang="ko-KR"/>
              <a:t>(Same post hoc analysis)</a:t>
            </a:r>
            <a:endParaRPr lang="en-US" altLang="ko-KR" dirty="0"/>
          </a:p>
          <a:p>
            <a:endParaRPr lang="en-US" altLang="ko-KR" dirty="0"/>
          </a:p>
          <a:p>
            <a:pPr marL="0" indent="0">
              <a:buNone/>
            </a:pPr>
            <a:r>
              <a:rPr lang="en-US" altLang="ko-KR" sz="3200" b="1" i="1">
                <a:solidFill>
                  <a:srgbClr val="0070C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∴ </a:t>
            </a:r>
            <a:r>
              <a:rPr lang="en-US" altLang="ko-KR" sz="3200" b="1" i="1">
                <a:solidFill>
                  <a:srgbClr val="0070C0"/>
                </a:solidFill>
              </a:rPr>
              <a:t>No difference in the interpretation of the results</a:t>
            </a:r>
            <a:endParaRPr lang="ko-KR" altLang="en-US" sz="3200" b="1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6081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97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Table S1 Analysis Results</vt:lpstr>
      <vt:lpstr>Vehicle(n=19)</vt:lpstr>
      <vt:lpstr>Vehicle(n=10)_First 10 mice in order of experimen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6 Analysis Results</dc:title>
  <dc:creator>ocsuser</dc:creator>
  <cp:lastModifiedBy>MDPI</cp:lastModifiedBy>
  <cp:revision>2</cp:revision>
  <dcterms:modified xsi:type="dcterms:W3CDTF">2023-04-11T03:10:09Z</dcterms:modified>
</cp:coreProperties>
</file>